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A743B-170C-C944-8EDF-7E68364B4F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8885D9-BB54-8541-B866-1C0D1D72B3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766A70-A721-0F4A-93EC-3B78A0CBE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763A52-2EC8-A04F-ABEE-539523F39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B6D2F-566F-1A4F-85AE-3B7CA00E7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111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2DB75F-FC46-7840-BB59-662675623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D9B12E-CE4F-5540-8091-0A86B66224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A10790-9A2A-C24E-94AF-52EAB7D15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C26828-5A40-4F41-BEB3-6ADFB46A3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9DEA1-E66B-9745-BC0C-3E0249173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0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184542-F45A-8F4E-93DE-5B482777F3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0B95E0-B144-0640-956F-1A4372DFFD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8D825B-0E6F-834F-96DE-F392B0E26F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21973C-598F-E44F-B456-72A3B757C2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D22D7F-B6F9-B848-B8B7-A6BC378B67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914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050BC9-A912-034F-8C80-8268AFC99D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D0AD1E-5E2B-604D-ABA4-DDFDF82BD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C5B8BC-905A-4041-8CC9-80A2587325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4D3043-FE1E-F54E-BA4B-54523F9C1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F2F93-1045-4C49-8484-3074EC355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066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724766-6D2E-734B-B212-2D0977024C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295FF5-02F5-6F45-8246-58D4362EBC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38D869-BAB3-D945-8642-7341BA547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CE3D27-889C-F441-AB61-456E63463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0C1D15-4B4A-C344-AEF9-C3640FE936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688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1216B-86AD-8C47-B7E2-E7AC9E360F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EAB0C7-31A3-CE46-A84C-7CD0247B74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827923-5544-C44E-988D-9D7D04775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12E030-2B1C-A74C-BDF9-F2284E969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89275D-256B-824E-9779-BAE3BE82EB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33F10B-DEF1-C040-8BDC-4EEE1AA063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888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B5EE5-AE89-2F43-875E-D19C32B687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D0ECCA-4B39-D84B-9A4A-9449B3887E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F701C6-7994-294F-8E84-320A944477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A7D8DC8-4476-CD45-ACD0-AC188BF5DC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02FD97-6108-8A42-9505-1933CDF87D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3D526D-1043-3248-9BB7-2BE6E8B65E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E7A0E4F-88D3-6540-9CB2-BEE66BD1F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BE46B7-0E44-4F4E-8DEB-7E24FB2E4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825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7D76EF-4FD2-4A4B-81FD-4F35A653C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5F1E51F-BFE4-4642-BB7D-6020AE67A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00D5A4-EC64-234E-B061-A5EA22FA2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2A5EEF-3BEA-2141-8D1D-F48A832BF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91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E361EA-A8F8-0347-8837-C30A7400C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E8150A8-AD98-B14A-9326-98F5F7160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BB2BAB5-B398-DF43-8F76-F4B5AAC556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398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0AA462-928E-8946-9E06-2FB1BA85A6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29CD0E-ABD3-7340-89D2-89503DDBF5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ABB740-538F-B441-8464-B274A9BEE4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0DD585-277D-8F4C-907C-D010276E6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254E1B-1361-DB46-85F7-A6CA4555E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499C31-1DF2-BF49-A7A8-9D81C1C6E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013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EF9A25-5406-C54A-9018-CC396B639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68DDE1-2C0C-C940-B7C4-62AC83F548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B11EDC-3F10-4D4F-879B-2FF2E96097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CB1265-9D57-004D-A8AE-58F9B7607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193990-01FA-1A4A-B0F7-1C6508DB3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91AE65-1C0B-7C42-A9FC-6619293012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503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210115-B555-414A-A7B6-63A1E20BBD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974C7A-2C5D-A94F-AF20-BBF1987334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EC6BAF-5E4F-6049-9502-93B2BCAA9E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F4B42-DF56-CB4C-BDC2-9869A597EA46}" type="datetimeFigureOut">
              <a:rPr lang="en-US" smtClean="0"/>
              <a:t>10/2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2CD061-E782-324F-856F-41E90D9790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D23987-E6ED-294F-A35D-DA2ECE49D9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E638A2-7D2C-1047-8B9E-69DF797C6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11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7F13720-1132-8F4F-8D06-12FAF957AC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870" y="0"/>
            <a:ext cx="777240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6F436BC-969A-8041-8870-5B8C79EEDF94}"/>
              </a:ext>
            </a:extLst>
          </p:cNvPr>
          <p:cNvSpPr txBox="1"/>
          <p:nvPr/>
        </p:nvSpPr>
        <p:spPr>
          <a:xfrm>
            <a:off x="7954616" y="5148469"/>
            <a:ext cx="4004879" cy="1384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5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networks for DEGs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volved under heat and drought stress in pink module.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ze of the node represent the degree.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1 transcription factors are represented green color and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 other 378 interacting nodes are represented in blue </a:t>
            </a:r>
          </a:p>
          <a:p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lor. All the edges are represented in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rksalm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lor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530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4</Words>
  <Application>Microsoft Macintosh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alingam, Mali - ARS</dc:creator>
  <cp:lastModifiedBy>Mahalingam, Mali - ARS</cp:lastModifiedBy>
  <cp:revision>2</cp:revision>
  <dcterms:created xsi:type="dcterms:W3CDTF">2022-09-30T14:27:38Z</dcterms:created>
  <dcterms:modified xsi:type="dcterms:W3CDTF">2022-10-21T03:32:31Z</dcterms:modified>
</cp:coreProperties>
</file>